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5" r:id="rId4"/>
    <p:sldId id="266" r:id="rId5"/>
    <p:sldId id="257" r:id="rId6"/>
    <p:sldId id="256" r:id="rId7"/>
    <p:sldId id="260" r:id="rId8"/>
    <p:sldId id="258" r:id="rId9"/>
    <p:sldId id="259" r:id="rId10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48" autoAdjust="0"/>
    <p:restoredTop sz="94660"/>
  </p:normalViewPr>
  <p:slideViewPr>
    <p:cSldViewPr snapToGrid="0">
      <p:cViewPr varScale="1">
        <p:scale>
          <a:sx n="69" d="100"/>
          <a:sy n="69" d="100"/>
        </p:scale>
        <p:origin x="37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24654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89834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23142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37994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05457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28347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25935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83162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75212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42978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0215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6CE8F-A6C5-476C-AA75-3B1F976A0A8C}" type="datetimeFigureOut">
              <a:rPr lang="sv-SE" smtClean="0"/>
              <a:t>2022-01-0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2F01A-B9BE-4588-A52D-BA1ADCECA13F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93071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C0F33DE-B6BF-46E8-9C5E-AB10AE5C6628}"/>
              </a:ext>
            </a:extLst>
          </p:cNvPr>
          <p:cNvSpPr txBox="1"/>
          <p:nvPr/>
        </p:nvSpPr>
        <p:spPr>
          <a:xfrm>
            <a:off x="3138055" y="467591"/>
            <a:ext cx="6328063" cy="43354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valuation of the RSR 3 Screen ICA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2 Screen ICA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M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 screening assays for type 1 diabetes in Sweden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ta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abetologica</a:t>
            </a:r>
            <a:endParaRPr lang="sv-SE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rina Törn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sv-SE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riba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ziri-Sani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ita Ramelius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Helena </a:t>
            </a:r>
            <a:r>
              <a:rPr lang="sv-SE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lding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arsson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ten Anders Ivarsson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arie Amoroso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sv-SE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dwiga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urmaniak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ichael Powell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rnard </a:t>
            </a:r>
            <a:r>
              <a:rPr lang="sv-SE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es</a:t>
            </a: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mith</a:t>
            </a:r>
            <a:r>
              <a:rPr lang="sv-SE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sv-SE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Clinical Sciences, Lund University, Malmö, Sweden</a:t>
            </a:r>
            <a:endParaRPr lang="sv-SE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und, Sweden</a:t>
            </a:r>
            <a:endParaRPr lang="sv-SE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RS Laboratories, RSR Ltd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lanishen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ardiff, UK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-mail: Corresponding author: Carina.Torn@med.lu.se</a:t>
            </a:r>
            <a:endParaRPr lang="sv-SE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48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8DCE3CE1-66BE-4555-86BF-A0CFD607D591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71" r="8850" b="5305"/>
          <a:stretch>
            <a:fillRect/>
          </a:stretch>
        </p:blipFill>
        <p:spPr bwMode="auto">
          <a:xfrm>
            <a:off x="5496574" y="1061345"/>
            <a:ext cx="4901336" cy="4038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1" name="TextBox 2">
            <a:extLst>
              <a:ext uri="{FF2B5EF4-FFF2-40B4-BE49-F238E27FC236}">
                <a16:creationId xmlns:a16="http://schemas.microsoft.com/office/drawing/2014/main" id="{55E17547-3F97-4F14-9E4F-61C05DCA32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09144" y="2783739"/>
            <a:ext cx="2315186" cy="3293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GB" sz="1540"/>
              <a:t>AUC=0.97 95%CI 0.95-0.99</a:t>
            </a:r>
            <a:endParaRPr lang="en-GB" altLang="en-GB" sz="1540"/>
          </a:p>
        </p:txBody>
      </p:sp>
      <p:sp>
        <p:nvSpPr>
          <p:cNvPr id="2052" name="TextBox 1">
            <a:extLst>
              <a:ext uri="{FF2B5EF4-FFF2-40B4-BE49-F238E27FC236}">
                <a16:creationId xmlns:a16="http://schemas.microsoft.com/office/drawing/2014/main" id="{0BD45FC6-AD7B-4349-A24E-1684FCD571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92125" y="428816"/>
            <a:ext cx="981551" cy="3686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GB" sz="1796"/>
              <a:t>2 Screen</a:t>
            </a:r>
            <a:endParaRPr lang="en-GB" altLang="en-GB" sz="1796"/>
          </a:p>
        </p:txBody>
      </p:sp>
      <p:pic>
        <p:nvPicPr>
          <p:cNvPr id="2053" name="Picture 2">
            <a:extLst>
              <a:ext uri="{FF2B5EF4-FFF2-40B4-BE49-F238E27FC236}">
                <a16:creationId xmlns:a16="http://schemas.microsoft.com/office/drawing/2014/main" id="{A0DE9DAD-E4FA-4FA2-AC8B-8DAB4B8BF3FD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20" t="223" r="15836" b="-223"/>
          <a:stretch>
            <a:fillRect/>
          </a:stretch>
        </p:blipFill>
        <p:spPr bwMode="auto">
          <a:xfrm>
            <a:off x="1524170" y="1061345"/>
            <a:ext cx="4459279" cy="4038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4" name="TextBox 2">
            <a:extLst>
              <a:ext uri="{FF2B5EF4-FFF2-40B4-BE49-F238E27FC236}">
                <a16:creationId xmlns:a16="http://schemas.microsoft.com/office/drawing/2014/main" id="{AB7C0C27-B4FD-4C50-9A70-5A72AA9CB9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3121" y="2784757"/>
            <a:ext cx="2315186" cy="3293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sv-SE" sz="1540"/>
              <a:t>AUC=0.96 95%CI 0.93-0.99</a:t>
            </a:r>
            <a:endParaRPr lang="en-GB" altLang="sv-SE" sz="1540"/>
          </a:p>
        </p:txBody>
      </p:sp>
      <p:sp>
        <p:nvSpPr>
          <p:cNvPr id="2055" name="TextBox 1">
            <a:extLst>
              <a:ext uri="{FF2B5EF4-FFF2-40B4-BE49-F238E27FC236}">
                <a16:creationId xmlns:a16="http://schemas.microsoft.com/office/drawing/2014/main" id="{AE14478B-936D-4167-B503-E8D233B18C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3694" y="429835"/>
            <a:ext cx="981551" cy="3686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sv-SE" sz="1796"/>
              <a:t>3 Screen</a:t>
            </a:r>
            <a:endParaRPr lang="en-GB" altLang="sv-SE" sz="1796"/>
          </a:p>
        </p:txBody>
      </p:sp>
      <p:sp>
        <p:nvSpPr>
          <p:cNvPr id="2056" name="TextBox 1">
            <a:extLst>
              <a:ext uri="{FF2B5EF4-FFF2-40B4-BE49-F238E27FC236}">
                <a16:creationId xmlns:a16="http://schemas.microsoft.com/office/drawing/2014/main" id="{850BF9CC-162C-4556-A32E-39672D1990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7999" y="513357"/>
            <a:ext cx="282450" cy="329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sv-SE" altLang="sv-SE" sz="1540" b="1"/>
              <a:t>a</a:t>
            </a:r>
          </a:p>
        </p:txBody>
      </p:sp>
      <p:sp>
        <p:nvSpPr>
          <p:cNvPr id="2057" name="TextBox 8">
            <a:extLst>
              <a:ext uri="{FF2B5EF4-FFF2-40B4-BE49-F238E27FC236}">
                <a16:creationId xmlns:a16="http://schemas.microsoft.com/office/drawing/2014/main" id="{61CC91E7-9089-490C-BABF-2E9A175EBE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58938" y="513357"/>
            <a:ext cx="290464" cy="329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sv-SE" altLang="sv-SE" sz="1540" b="1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FD5AAB7-65B8-45BE-8980-EF64A145CCFB}"/>
              </a:ext>
            </a:extLst>
          </p:cNvPr>
          <p:cNvSpPr txBox="1"/>
          <p:nvPr/>
        </p:nvSpPr>
        <p:spPr>
          <a:xfrm>
            <a:off x="96814" y="67593"/>
            <a:ext cx="38982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1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1">
            <a:extLst>
              <a:ext uri="{FF2B5EF4-FFF2-40B4-BE49-F238E27FC236}">
                <a16:creationId xmlns:a16="http://schemas.microsoft.com/office/drawing/2014/main" id="{DB9253FC-A75F-436F-BC61-121AEA281B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3182" y="368721"/>
            <a:ext cx="268022" cy="329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sv-SE" altLang="sv-SE" sz="1540" b="1"/>
              <a:t>c</a:t>
            </a:r>
          </a:p>
        </p:txBody>
      </p:sp>
      <p:sp>
        <p:nvSpPr>
          <p:cNvPr id="3075" name="TextBox 2">
            <a:extLst>
              <a:ext uri="{FF2B5EF4-FFF2-40B4-BE49-F238E27FC236}">
                <a16:creationId xmlns:a16="http://schemas.microsoft.com/office/drawing/2014/main" id="{9BA38B18-A23F-4727-BF1C-97AC89A960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86439" y="368721"/>
            <a:ext cx="290464" cy="329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sv-SE" altLang="sv-SE" sz="1540" b="1"/>
              <a:t>d</a:t>
            </a:r>
          </a:p>
        </p:txBody>
      </p:sp>
      <p:sp>
        <p:nvSpPr>
          <p:cNvPr id="3076" name="TextBox 3">
            <a:extLst>
              <a:ext uri="{FF2B5EF4-FFF2-40B4-BE49-F238E27FC236}">
                <a16:creationId xmlns:a16="http://schemas.microsoft.com/office/drawing/2014/main" id="{BB674D59-A009-41A8-B826-9EA8AA5A2A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8184" y="3508958"/>
            <a:ext cx="284052" cy="329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sv-SE" altLang="sv-SE" sz="1540" b="1"/>
              <a:t>e</a:t>
            </a:r>
          </a:p>
        </p:txBody>
      </p:sp>
      <p:pic>
        <p:nvPicPr>
          <p:cNvPr id="3077" name="Picture 2">
            <a:extLst>
              <a:ext uri="{FF2B5EF4-FFF2-40B4-BE49-F238E27FC236}">
                <a16:creationId xmlns:a16="http://schemas.microsoft.com/office/drawing/2014/main" id="{02BE3A74-689B-4F53-9053-47E37A63FD5F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57" t="-633" r="737" b="6511"/>
          <a:stretch>
            <a:fillRect/>
          </a:stretch>
        </p:blipFill>
        <p:spPr bwMode="auto">
          <a:xfrm>
            <a:off x="2136328" y="665124"/>
            <a:ext cx="3827768" cy="27470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8" name="TextBox 1">
            <a:extLst>
              <a:ext uri="{FF2B5EF4-FFF2-40B4-BE49-F238E27FC236}">
                <a16:creationId xmlns:a16="http://schemas.microsoft.com/office/drawing/2014/main" id="{EBC90FCF-DF47-4AEB-AC72-1D559DE450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3609" y="533728"/>
            <a:ext cx="1288879" cy="368691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sv-SE" sz="1796"/>
              <a:t>GADA ELISA</a:t>
            </a:r>
            <a:endParaRPr lang="en-GB" altLang="sv-SE" sz="1796"/>
          </a:p>
        </p:txBody>
      </p:sp>
      <p:sp>
        <p:nvSpPr>
          <p:cNvPr id="3079" name="TextBox 2">
            <a:extLst>
              <a:ext uri="{FF2B5EF4-FFF2-40B4-BE49-F238E27FC236}">
                <a16:creationId xmlns:a16="http://schemas.microsoft.com/office/drawing/2014/main" id="{4DC08490-5813-42A0-A123-BB53030CA9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6092" y="1890457"/>
            <a:ext cx="2315186" cy="3293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sv-SE" sz="1540"/>
              <a:t>AUC=0.91 95%CI 0.87-0.96</a:t>
            </a:r>
            <a:endParaRPr lang="en-GB" altLang="sv-SE" sz="1540"/>
          </a:p>
        </p:txBody>
      </p:sp>
      <p:pic>
        <p:nvPicPr>
          <p:cNvPr id="3080" name="Picture 2">
            <a:extLst>
              <a:ext uri="{FF2B5EF4-FFF2-40B4-BE49-F238E27FC236}">
                <a16:creationId xmlns:a16="http://schemas.microsoft.com/office/drawing/2014/main" id="{F1F97CC7-E346-452F-B647-E7F0914EDBFC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39" t="316" r="246" b="5278"/>
          <a:stretch>
            <a:fillRect/>
          </a:stretch>
        </p:blipFill>
        <p:spPr bwMode="auto">
          <a:xfrm>
            <a:off x="6828858" y="652901"/>
            <a:ext cx="3405064" cy="27592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81" name="TextBox 2">
            <a:extLst>
              <a:ext uri="{FF2B5EF4-FFF2-40B4-BE49-F238E27FC236}">
                <a16:creationId xmlns:a16="http://schemas.microsoft.com/office/drawing/2014/main" id="{889D40AD-8D26-48AF-A8EA-BC70DBA0E1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39816" y="1742765"/>
            <a:ext cx="2315186" cy="3293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sv-SE" sz="1540"/>
              <a:t>AUC=0.95 95%CI 0.92-0.98</a:t>
            </a:r>
            <a:endParaRPr lang="en-GB" altLang="sv-SE" sz="1540"/>
          </a:p>
        </p:txBody>
      </p:sp>
      <p:pic>
        <p:nvPicPr>
          <p:cNvPr id="3082" name="Picture 2">
            <a:extLst>
              <a:ext uri="{FF2B5EF4-FFF2-40B4-BE49-F238E27FC236}">
                <a16:creationId xmlns:a16="http://schemas.microsoft.com/office/drawing/2014/main" id="{70F67810-0B9A-4611-80F7-FD242B5B103C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11" t="911" r="4912" b="6458"/>
          <a:stretch>
            <a:fillRect/>
          </a:stretch>
        </p:blipFill>
        <p:spPr bwMode="auto">
          <a:xfrm>
            <a:off x="2466343" y="3656649"/>
            <a:ext cx="3272650" cy="26441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83" name="TextBox 1">
            <a:extLst>
              <a:ext uri="{FF2B5EF4-FFF2-40B4-BE49-F238E27FC236}">
                <a16:creationId xmlns:a16="http://schemas.microsoft.com/office/drawing/2014/main" id="{6C4BCF1B-F891-4A4B-B066-3F5CDB3BBD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93078" y="390111"/>
            <a:ext cx="1250599" cy="368691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sv-SE" sz="1796"/>
              <a:t>IA-2A ELISA</a:t>
            </a:r>
            <a:endParaRPr lang="en-GB" altLang="sv-SE" sz="1796"/>
          </a:p>
        </p:txBody>
      </p:sp>
      <p:sp>
        <p:nvSpPr>
          <p:cNvPr id="3084" name="TextBox 1">
            <a:extLst>
              <a:ext uri="{FF2B5EF4-FFF2-40B4-BE49-F238E27FC236}">
                <a16:creationId xmlns:a16="http://schemas.microsoft.com/office/drawing/2014/main" id="{1B6B5A0F-5CF1-4356-B107-336544B25E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6659" y="3599610"/>
            <a:ext cx="1329146" cy="368691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sv-SE" sz="1796"/>
              <a:t>ZnT8A ELISA</a:t>
            </a:r>
            <a:endParaRPr lang="en-GB" altLang="sv-SE" sz="1796"/>
          </a:p>
        </p:txBody>
      </p:sp>
      <p:sp>
        <p:nvSpPr>
          <p:cNvPr id="3085" name="TextBox 2">
            <a:extLst>
              <a:ext uri="{FF2B5EF4-FFF2-40B4-BE49-F238E27FC236}">
                <a16:creationId xmlns:a16="http://schemas.microsoft.com/office/drawing/2014/main" id="{F8715054-00A2-4DA8-B5E2-8DB90F330A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6092" y="4821888"/>
            <a:ext cx="2315186" cy="3293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sv-SE" sz="1540"/>
              <a:t>AUC=0.86 95%CI 0.80-0.92</a:t>
            </a:r>
            <a:endParaRPr lang="en-GB" altLang="sv-SE" sz="154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38DD2BB-B607-4C5B-886B-0416993A6236}"/>
              </a:ext>
            </a:extLst>
          </p:cNvPr>
          <p:cNvSpPr txBox="1"/>
          <p:nvPr/>
        </p:nvSpPr>
        <p:spPr>
          <a:xfrm>
            <a:off x="119743" y="33146"/>
            <a:ext cx="38982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1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0FFD1F9-8937-494E-AB0B-2E0B51E4123D}"/>
              </a:ext>
            </a:extLst>
          </p:cNvPr>
          <p:cNvSpPr txBox="1"/>
          <p:nvPr/>
        </p:nvSpPr>
        <p:spPr>
          <a:xfrm>
            <a:off x="508959" y="544646"/>
            <a:ext cx="10351698" cy="50608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28040" indent="-828040"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Information Figure legends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828040" marR="0" indent="-82804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 	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a under the curve (AUC) from Receiver operator characteristic (ROC)-				curves constructed for the enzyme linked immunosorbent assays (ELISAs).</a:t>
            </a:r>
            <a:endParaRPr lang="sv-SE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a 3 Screen</a:t>
            </a:r>
            <a:endParaRPr lang="sv-SE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b 2 Screen</a:t>
            </a:r>
            <a:endParaRPr lang="sv-SE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c GADA ELISA</a:t>
            </a:r>
            <a:endParaRPr lang="sv-SE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sv-S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d IA-2A ELISA</a:t>
            </a:r>
            <a:endParaRPr lang="sv-SE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e ZnT8A ELISA</a:t>
            </a:r>
            <a:endParaRPr lang="sv-SE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85382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886111" y="259051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464657" y="25905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b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86111" y="361868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c</a:t>
            </a:r>
          </a:p>
        </p:txBody>
      </p:sp>
      <p:pic>
        <p:nvPicPr>
          <p:cNvPr id="12" name="Picture 2">
            <a:extLst>
              <a:ext uri="{FF2B5EF4-FFF2-40B4-BE49-F238E27FC236}">
                <a16:creationId xmlns:a16="http://schemas.microsoft.com/office/drawing/2014/main" id="{F09979BC-419D-4C6E-82E8-50A75CAE2430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0771" y="288444"/>
            <a:ext cx="4680000" cy="32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B1743A4-B338-4381-B32B-409C5AF44B74}"/>
              </a:ext>
            </a:extLst>
          </p:cNvPr>
          <p:cNvSpPr txBox="1"/>
          <p:nvPr/>
        </p:nvSpPr>
        <p:spPr>
          <a:xfrm>
            <a:off x="2337673" y="563139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625; p&lt;0.001</a:t>
            </a:r>
          </a:p>
          <a:p>
            <a:r>
              <a:rPr lang="sv-SE" sz="1400" dirty="0"/>
              <a:t>N=83</a:t>
            </a:r>
          </a:p>
        </p:txBody>
      </p:sp>
      <p:pic>
        <p:nvPicPr>
          <p:cNvPr id="16" name="Picture 2">
            <a:extLst>
              <a:ext uri="{FF2B5EF4-FFF2-40B4-BE49-F238E27FC236}">
                <a16:creationId xmlns:a16="http://schemas.microsoft.com/office/drawing/2014/main" id="{B0B643B8-6844-4315-9834-8254477657CB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0773" y="3591825"/>
            <a:ext cx="4680000" cy="32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B2209C2-67FC-4F29-9692-EEB720E3D4B9}"/>
              </a:ext>
            </a:extLst>
          </p:cNvPr>
          <p:cNvSpPr txBox="1"/>
          <p:nvPr/>
        </p:nvSpPr>
        <p:spPr>
          <a:xfrm>
            <a:off x="3873673" y="5581630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244; p=0.003</a:t>
            </a:r>
          </a:p>
          <a:p>
            <a:r>
              <a:rPr lang="sv-SE" sz="1400" dirty="0"/>
              <a:t>N=7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4B9F74F-776C-430D-9467-114DD62F7CFC}"/>
              </a:ext>
            </a:extLst>
          </p:cNvPr>
          <p:cNvSpPr txBox="1"/>
          <p:nvPr/>
        </p:nvSpPr>
        <p:spPr>
          <a:xfrm>
            <a:off x="2963852" y="6569556"/>
            <a:ext cx="187769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ZnT8A ELISA (units/mL)</a:t>
            </a:r>
            <a:endParaRPr lang="en-SE"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B4D79DF-13A8-4355-8263-D575FB3A9E8D}"/>
              </a:ext>
            </a:extLst>
          </p:cNvPr>
          <p:cNvSpPr txBox="1"/>
          <p:nvPr/>
        </p:nvSpPr>
        <p:spPr>
          <a:xfrm rot="16200000">
            <a:off x="405692" y="1590020"/>
            <a:ext cx="1645835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/>
              <a:t> 3 Screen (units/mL)</a:t>
            </a:r>
            <a:endParaRPr lang="en-SE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3EA2317-5FB5-43E6-B982-81B6E9913984}"/>
              </a:ext>
            </a:extLst>
          </p:cNvPr>
          <p:cNvSpPr txBox="1"/>
          <p:nvPr/>
        </p:nvSpPr>
        <p:spPr>
          <a:xfrm rot="16200000">
            <a:off x="446250" y="4980240"/>
            <a:ext cx="1605761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3 Screen (units/mL)</a:t>
            </a:r>
            <a:endParaRPr lang="en-SE" sz="14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09E4C42-D1BA-4DB7-80EC-1EA9744B520C}"/>
              </a:ext>
            </a:extLst>
          </p:cNvPr>
          <p:cNvSpPr txBox="1"/>
          <p:nvPr/>
        </p:nvSpPr>
        <p:spPr>
          <a:xfrm>
            <a:off x="-24614" y="-44924"/>
            <a:ext cx="38982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2</a:t>
            </a:r>
          </a:p>
        </p:txBody>
      </p:sp>
      <p:pic>
        <p:nvPicPr>
          <p:cNvPr id="20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4357" y="495722"/>
            <a:ext cx="5368868" cy="298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AADFF98-4C2E-473A-A83A-E5AEF9238A5A}"/>
              </a:ext>
            </a:extLst>
          </p:cNvPr>
          <p:cNvSpPr txBox="1"/>
          <p:nvPr/>
        </p:nvSpPr>
        <p:spPr>
          <a:xfrm>
            <a:off x="8924258" y="3239316"/>
            <a:ext cx="156831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IA-2A ELISA (U/mL)</a:t>
            </a:r>
            <a:endParaRPr lang="en-SE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B4D79DF-13A8-4355-8263-D575FB3A9E8D}"/>
              </a:ext>
            </a:extLst>
          </p:cNvPr>
          <p:cNvSpPr txBox="1"/>
          <p:nvPr/>
        </p:nvSpPr>
        <p:spPr>
          <a:xfrm rot="16200000">
            <a:off x="6142393" y="1504203"/>
            <a:ext cx="1442784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 3 Screen (units/mL)</a:t>
            </a:r>
            <a:endParaRPr lang="en-SE"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8B6272B-CF1F-4DDF-9CE3-F668587E954B}"/>
              </a:ext>
            </a:extLst>
          </p:cNvPr>
          <p:cNvSpPr txBox="1"/>
          <p:nvPr/>
        </p:nvSpPr>
        <p:spPr>
          <a:xfrm>
            <a:off x="10155703" y="2203690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678; p&lt;0.001</a:t>
            </a:r>
          </a:p>
          <a:p>
            <a:r>
              <a:rPr lang="sv-SE" sz="1400" dirty="0"/>
              <a:t>N=7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FCE957E-2A00-44A9-86B0-73A1FE673749}"/>
              </a:ext>
            </a:extLst>
          </p:cNvPr>
          <p:cNvSpPr txBox="1"/>
          <p:nvPr/>
        </p:nvSpPr>
        <p:spPr>
          <a:xfrm>
            <a:off x="2963852" y="3275111"/>
            <a:ext cx="176542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GADA ELISA (U/mL)</a:t>
            </a:r>
          </a:p>
        </p:txBody>
      </p:sp>
    </p:spTree>
    <p:extLst>
      <p:ext uri="{BB962C8B-B14F-4D97-AF65-F5344CB8AC3E}">
        <p14:creationId xmlns:p14="http://schemas.microsoft.com/office/powerpoint/2010/main" val="2234938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320980" y="34838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d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944450" y="34838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e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234720" y="3551222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f</a:t>
            </a:r>
          </a:p>
        </p:txBody>
      </p:sp>
      <p:pic>
        <p:nvPicPr>
          <p:cNvPr id="12" name="Picture 2">
            <a:extLst>
              <a:ext uri="{FF2B5EF4-FFF2-40B4-BE49-F238E27FC236}">
                <a16:creationId xmlns:a16="http://schemas.microsoft.com/office/drawing/2014/main" id="{0F2B4B4A-3B07-493F-A826-116A76822D34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1911" y="333931"/>
            <a:ext cx="4680000" cy="32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2355913" y="640083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802; p&lt;0.001</a:t>
            </a:r>
          </a:p>
          <a:p>
            <a:r>
              <a:rPr lang="sv-SE" sz="1400" dirty="0"/>
              <a:t>N=91</a:t>
            </a:r>
          </a:p>
        </p:txBody>
      </p:sp>
      <p:pic>
        <p:nvPicPr>
          <p:cNvPr id="13" name="Picture 2">
            <a:extLst>
              <a:ext uri="{FF2B5EF4-FFF2-40B4-BE49-F238E27FC236}">
                <a16:creationId xmlns:a16="http://schemas.microsoft.com/office/drawing/2014/main" id="{85921F48-84A2-4FF9-9E7B-4994331BD852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5551" y="378473"/>
            <a:ext cx="4680000" cy="32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C9C2CD4C-3D6F-4ED9-8B84-52E04DBB2958}"/>
              </a:ext>
            </a:extLst>
          </p:cNvPr>
          <p:cNvSpPr txBox="1"/>
          <p:nvPr/>
        </p:nvSpPr>
        <p:spPr>
          <a:xfrm>
            <a:off x="9914732" y="2476126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691; p&lt;0.001</a:t>
            </a:r>
          </a:p>
          <a:p>
            <a:r>
              <a:rPr lang="sv-SE" sz="1400" dirty="0"/>
              <a:t>N=82</a:t>
            </a:r>
          </a:p>
        </p:txBody>
      </p:sp>
      <p:pic>
        <p:nvPicPr>
          <p:cNvPr id="14" name="Picture 2">
            <a:extLst>
              <a:ext uri="{FF2B5EF4-FFF2-40B4-BE49-F238E27FC236}">
                <a16:creationId xmlns:a16="http://schemas.microsoft.com/office/drawing/2014/main" id="{43C0E176-7301-41BF-9172-07D71B23ED53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7651" y="3582000"/>
            <a:ext cx="4680000" cy="32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11536B8-16A8-4BF6-8799-5BC11DDA5774}"/>
              </a:ext>
            </a:extLst>
          </p:cNvPr>
          <p:cNvSpPr txBox="1"/>
          <p:nvPr/>
        </p:nvSpPr>
        <p:spPr>
          <a:xfrm>
            <a:off x="4283044" y="5583071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599; p&lt;0.001</a:t>
            </a:r>
          </a:p>
          <a:p>
            <a:r>
              <a:rPr lang="sv-SE" sz="1400" dirty="0"/>
              <a:t>N=7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4E5AD46-A183-4953-A44A-7A7CCF594A5D}"/>
              </a:ext>
            </a:extLst>
          </p:cNvPr>
          <p:cNvSpPr txBox="1"/>
          <p:nvPr/>
        </p:nvSpPr>
        <p:spPr>
          <a:xfrm>
            <a:off x="3413902" y="3346696"/>
            <a:ext cx="135889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2 Screen (U/mL)</a:t>
            </a:r>
            <a:endParaRPr lang="en-SE"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6B76E25-6D09-42C8-87F8-9B4C3C4B1339}"/>
              </a:ext>
            </a:extLst>
          </p:cNvPr>
          <p:cNvSpPr txBox="1"/>
          <p:nvPr/>
        </p:nvSpPr>
        <p:spPr>
          <a:xfrm rot="16200000">
            <a:off x="6480794" y="1608917"/>
            <a:ext cx="142664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2 Screen (U/mL)</a:t>
            </a:r>
            <a:endParaRPr lang="en-SE"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C0FFD15-507F-460D-A902-0352B603A045}"/>
              </a:ext>
            </a:extLst>
          </p:cNvPr>
          <p:cNvSpPr txBox="1"/>
          <p:nvPr/>
        </p:nvSpPr>
        <p:spPr>
          <a:xfrm rot="16200000">
            <a:off x="853918" y="1608916"/>
            <a:ext cx="1605761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3 Screen (units/mL)</a:t>
            </a:r>
            <a:endParaRPr lang="en-SE"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36B1BB0-A767-4BAF-ADE9-6C823E02A99B}"/>
              </a:ext>
            </a:extLst>
          </p:cNvPr>
          <p:cNvSpPr txBox="1"/>
          <p:nvPr/>
        </p:nvSpPr>
        <p:spPr>
          <a:xfrm rot="16200000">
            <a:off x="906218" y="4823114"/>
            <a:ext cx="142664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2 Screen (U/mL)</a:t>
            </a:r>
            <a:endParaRPr lang="en-SE" sz="14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14B6D80-8FB6-4EB7-B39F-A04D05730203}"/>
              </a:ext>
            </a:extLst>
          </p:cNvPr>
          <p:cNvSpPr txBox="1"/>
          <p:nvPr/>
        </p:nvSpPr>
        <p:spPr>
          <a:xfrm>
            <a:off x="3327642" y="6550223"/>
            <a:ext cx="156831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IA-2A ELISA (U/mL)</a:t>
            </a:r>
            <a:endParaRPr lang="en-SE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451A598-CE16-4679-A64A-063507CDE35C}"/>
              </a:ext>
            </a:extLst>
          </p:cNvPr>
          <p:cNvSpPr txBox="1"/>
          <p:nvPr/>
        </p:nvSpPr>
        <p:spPr>
          <a:xfrm>
            <a:off x="9045670" y="3428111"/>
            <a:ext cx="159934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GADA ELISA (U/mL)</a:t>
            </a:r>
            <a:endParaRPr lang="en-SE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3738920-0E11-4068-B2FA-C18A94EEEB29}"/>
              </a:ext>
            </a:extLst>
          </p:cNvPr>
          <p:cNvSpPr txBox="1"/>
          <p:nvPr/>
        </p:nvSpPr>
        <p:spPr>
          <a:xfrm>
            <a:off x="-24614" y="-44924"/>
            <a:ext cx="38982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21109875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70936" y="267719"/>
            <a:ext cx="11102196" cy="56148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828040" indent="-82804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	Correlations in autoantibody levels between combined enzyme linked immunosorbent 			assays (ELISAs) and corresponding single autoantibody ELISAs using the instruction 			for use (IFU) cut offs.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a	3 Screen and GADA ELISA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b	3 Screen and IA-2A ELISA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c	3 Screen and ZnT8A ELISA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d	3 Screen and 2 Screen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e	2 Screen and GADA ELISA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f	2 Screen and IA-2A ELISA</a:t>
            </a:r>
            <a:endParaRPr lang="sv-SE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9221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073533" y="22031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524292" y="22031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b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073533" y="341092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6524292" y="349985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d</a:t>
            </a:r>
          </a:p>
        </p:txBody>
      </p:sp>
      <p:pic>
        <p:nvPicPr>
          <p:cNvPr id="26" name="Picture 2">
            <a:extLst>
              <a:ext uri="{FF2B5EF4-FFF2-40B4-BE49-F238E27FC236}">
                <a16:creationId xmlns:a16="http://schemas.microsoft.com/office/drawing/2014/main" id="{15597F6E-B7D6-4682-9473-75696F2E53C2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4386" y="218855"/>
            <a:ext cx="4680000" cy="32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3989160" y="2227959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949; p&lt;0.001</a:t>
            </a:r>
          </a:p>
          <a:p>
            <a:r>
              <a:rPr lang="sv-SE" sz="1400" dirty="0"/>
              <a:t>N=76</a:t>
            </a:r>
          </a:p>
        </p:txBody>
      </p:sp>
      <p:pic>
        <p:nvPicPr>
          <p:cNvPr id="27" name="Picture 2">
            <a:extLst>
              <a:ext uri="{FF2B5EF4-FFF2-40B4-BE49-F238E27FC236}">
                <a16:creationId xmlns:a16="http://schemas.microsoft.com/office/drawing/2014/main" id="{97EA962D-92AC-4C6C-9646-FE21A0BE33CF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1626" y="279045"/>
            <a:ext cx="4680000" cy="327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7676634" y="688241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588; p&lt;0.001</a:t>
            </a:r>
          </a:p>
          <a:p>
            <a:r>
              <a:rPr lang="sv-SE" sz="1400" dirty="0"/>
              <a:t>N=72</a:t>
            </a:r>
          </a:p>
        </p:txBody>
      </p:sp>
      <p:pic>
        <p:nvPicPr>
          <p:cNvPr id="28" name="Picture 2">
            <a:extLst>
              <a:ext uri="{FF2B5EF4-FFF2-40B4-BE49-F238E27FC236}">
                <a16:creationId xmlns:a16="http://schemas.microsoft.com/office/drawing/2014/main" id="{AC68C33D-6258-437D-94B6-4411A6609FD4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4386" y="3425265"/>
            <a:ext cx="4680000" cy="324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2148216" y="3697277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723; p&lt;0.001</a:t>
            </a:r>
          </a:p>
          <a:p>
            <a:r>
              <a:rPr lang="sv-SE" sz="1400" dirty="0"/>
              <a:t>N=50</a:t>
            </a:r>
          </a:p>
        </p:txBody>
      </p:sp>
      <p:pic>
        <p:nvPicPr>
          <p:cNvPr id="29" name="Picture 2">
            <a:extLst>
              <a:ext uri="{FF2B5EF4-FFF2-40B4-BE49-F238E27FC236}">
                <a16:creationId xmlns:a16="http://schemas.microsoft.com/office/drawing/2014/main" id="{D5D042ED-2559-497E-BFEF-ED9486EFC220}"/>
              </a:ext>
            </a:extLst>
          </p:cNvPr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0538" y="3555045"/>
            <a:ext cx="4680000" cy="324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7714344" y="3915182"/>
            <a:ext cx="1535998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sv-SE" sz="1400" dirty="0"/>
              <a:t>Rs=0.405; p=0.009</a:t>
            </a:r>
          </a:p>
          <a:p>
            <a:r>
              <a:rPr lang="sv-SE" sz="1400" dirty="0"/>
              <a:t>N=4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52EAF4E-CB65-43F9-B81C-12A0EF356AC2}"/>
              </a:ext>
            </a:extLst>
          </p:cNvPr>
          <p:cNvSpPr txBox="1"/>
          <p:nvPr/>
        </p:nvSpPr>
        <p:spPr>
          <a:xfrm>
            <a:off x="8482343" y="6476221"/>
            <a:ext cx="1989391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ZnT8-WA RBA (units/mL)</a:t>
            </a:r>
            <a:endParaRPr lang="en-SE"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59526D4-8B45-4EEE-8D20-16C9DED248B7}"/>
              </a:ext>
            </a:extLst>
          </p:cNvPr>
          <p:cNvSpPr txBox="1"/>
          <p:nvPr/>
        </p:nvSpPr>
        <p:spPr>
          <a:xfrm>
            <a:off x="3069005" y="6388265"/>
            <a:ext cx="193501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ZnT8-RA RBA (units/mL)</a:t>
            </a:r>
            <a:endParaRPr lang="en-SE"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A8419D3-1442-4C6E-AF5A-874BEB68C0D4}"/>
              </a:ext>
            </a:extLst>
          </p:cNvPr>
          <p:cNvSpPr txBox="1"/>
          <p:nvPr/>
        </p:nvSpPr>
        <p:spPr>
          <a:xfrm>
            <a:off x="8772379" y="3273448"/>
            <a:ext cx="172021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IA-2A RBA (units/mL)</a:t>
            </a:r>
            <a:endParaRPr lang="en-SE"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3E95193-596A-4431-BFE8-04C9A1AAF7BB}"/>
              </a:ext>
            </a:extLst>
          </p:cNvPr>
          <p:cNvSpPr txBox="1"/>
          <p:nvPr/>
        </p:nvSpPr>
        <p:spPr>
          <a:xfrm>
            <a:off x="3069005" y="3227922"/>
            <a:ext cx="175124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GADA RBA (units/mL)</a:t>
            </a:r>
            <a:endParaRPr lang="en-SE" sz="14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C6119CE-EE16-4657-8646-36CA6824C355}"/>
              </a:ext>
            </a:extLst>
          </p:cNvPr>
          <p:cNvSpPr txBox="1"/>
          <p:nvPr/>
        </p:nvSpPr>
        <p:spPr>
          <a:xfrm rot="16200000">
            <a:off x="6147643" y="1565395"/>
            <a:ext cx="156831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IA-2A ELISA (U/mL)</a:t>
            </a:r>
            <a:endParaRPr lang="en-SE" sz="14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D9759BC-766E-4F3F-A8CA-D2E5A7AE27BF}"/>
              </a:ext>
            </a:extLst>
          </p:cNvPr>
          <p:cNvSpPr txBox="1"/>
          <p:nvPr/>
        </p:nvSpPr>
        <p:spPr>
          <a:xfrm rot="16200000">
            <a:off x="583984" y="1483506"/>
            <a:ext cx="159934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GADA ELISA (U/mL)</a:t>
            </a:r>
            <a:endParaRPr lang="en-SE" sz="14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0F868EE-020B-4CA0-A6CD-3581E676C44B}"/>
              </a:ext>
            </a:extLst>
          </p:cNvPr>
          <p:cNvSpPr txBox="1"/>
          <p:nvPr/>
        </p:nvSpPr>
        <p:spPr>
          <a:xfrm rot="16200000">
            <a:off x="468410" y="4557982"/>
            <a:ext cx="186322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ZnT8A ELISA (units/mL)</a:t>
            </a:r>
            <a:endParaRPr lang="en-SE" sz="14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A7F3E8E-DE68-42F3-8164-C4ECDFA6E3C3}"/>
              </a:ext>
            </a:extLst>
          </p:cNvPr>
          <p:cNvSpPr txBox="1"/>
          <p:nvPr/>
        </p:nvSpPr>
        <p:spPr>
          <a:xfrm rot="16200000">
            <a:off x="5967460" y="4590310"/>
            <a:ext cx="192788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/>
              <a:t>ZnT8A ELISA (units/mL)</a:t>
            </a:r>
            <a:endParaRPr lang="en-SE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42973ED-2A23-451E-AB50-D75FB2F48CB8}"/>
              </a:ext>
            </a:extLst>
          </p:cNvPr>
          <p:cNvSpPr txBox="1"/>
          <p:nvPr/>
        </p:nvSpPr>
        <p:spPr>
          <a:xfrm rot="16200000">
            <a:off x="6148803" y="1572618"/>
            <a:ext cx="156831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IA-2A ELISA (U/mL)</a:t>
            </a:r>
            <a:endParaRPr lang="en-SE" sz="14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F676184-C61A-45C8-8473-ED7B264A860D}"/>
              </a:ext>
            </a:extLst>
          </p:cNvPr>
          <p:cNvSpPr txBox="1"/>
          <p:nvPr/>
        </p:nvSpPr>
        <p:spPr>
          <a:xfrm>
            <a:off x="-35717" y="-94665"/>
            <a:ext cx="3719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6210254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707366" y="796338"/>
            <a:ext cx="10765765" cy="49582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828040" indent="-82804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	 Correlations in autoantibody levels between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diobinding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says (RBAs) and 				corresponding enzyme linked immunosorbent assays (ELISAs) using the instruction 			for use (IFU) cut offs.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sv-SE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a	GADA ELISA and GADA RBA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b 	IA-2A ELISA and IA-2A RBA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c	ZnT8A ELISA and ZnT8-RA RBA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 d 	ZnT8A ELISA and ZnT8-WA RBA</a:t>
            </a:r>
            <a:endParaRPr lang="sv-SE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200000"/>
              </a:lnSpc>
              <a:spcAft>
                <a:spcPts val="80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sv-SE" sz="16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71985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504</Words>
  <Application>Microsoft Office PowerPoint</Application>
  <PresentationFormat>Widescreen</PresentationFormat>
  <Paragraphs>10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unds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d-cto</dc:creator>
  <cp:lastModifiedBy>Carina Törn</cp:lastModifiedBy>
  <cp:revision>34</cp:revision>
  <cp:lastPrinted>2021-02-16T13:22:08Z</cp:lastPrinted>
  <dcterms:created xsi:type="dcterms:W3CDTF">2019-05-01T14:30:14Z</dcterms:created>
  <dcterms:modified xsi:type="dcterms:W3CDTF">2022-01-07T10:57:21Z</dcterms:modified>
</cp:coreProperties>
</file>